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360BCF-2199-4598-92FD-D54BD18AC02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B4DCB8-1E2F-4DE1-B339-BCFFF675318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435C64-F7AB-4869-9B0A-A22ADA9132F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432F7A-3574-4B33-AC94-2E665FBBE87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5A58FB-5A7D-469F-9F04-77FB85238B5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EC38B9-632C-493D-A0BF-5E9FD347393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665CE1-C1E3-4220-839A-84EEE6482C6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148AED-D6BE-4AE2-95DE-54D6F8C9D71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440872-91B2-4F5A-8FB4-D4722D4E7B7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F3B50F-C1CA-4A21-8B76-2C377766FD0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29A3F4-BFE0-45B5-A367-9469C60B074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A37D63-5375-41B2-BABB-C6FD9C0733B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D6B0226-4F17-49D5-81E5-ACD013FE4E4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1414440" y="241200"/>
            <a:ext cx="3898800" cy="771696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593640" y="8047080"/>
            <a:ext cx="587376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Histogram of the 8-mer-association-with-RNAP between -1,000 bp and +500 bp for abundant 8-mers with 8-mers containing each of the 10 dinucleotides noted in black.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48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nci</cp:lastModifiedBy>
  <cp:lastPrinted>2007-10-01T20:46:28Z</cp:lastPrinted>
  <dcterms:modified xsi:type="dcterms:W3CDTF">2008-01-21T03:30:15Z</dcterms:modified>
  <cp:revision>390</cp:revision>
  <dc:subject/>
  <dc:title>PowerPoint Presentation</dc:title>
</cp:coreProperties>
</file>